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8"/>
  </p:notesMasterIdLst>
  <p:sldIdLst>
    <p:sldId id="261" r:id="rId2"/>
    <p:sldId id="262" r:id="rId3"/>
    <p:sldId id="263" r:id="rId4"/>
    <p:sldId id="271" r:id="rId5"/>
    <p:sldId id="273" r:id="rId6"/>
    <p:sldId id="268" r:id="rId7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6" roundtripDataSignature="AMtx7miXrvtHb5SWpEKsK9+OFPa/51KGn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251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9" Type="http://schemas.openxmlformats.org/officeDocument/2006/relationships/theme" Target="theme/theme1.xml"/><Relationship Id="rId4" Type="http://schemas.openxmlformats.org/officeDocument/2006/relationships/slide" Target="slides/slide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Google Shape;171;p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72" name="Google Shape;172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Google Shape;177;p2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78" name="Google Shape;178;p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Google Shape;183;p2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84" name="Google Shape;184;p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Google Shape;171;p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72" name="Google Shape;172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23360908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9"/>
          <p:cNvSpPr txBox="1"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9"/>
          <p:cNvSpPr txBox="1"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4" name="Google Shape;24;p9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9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9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0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1" name="Google Shape;31;p10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1"/>
          <p:cNvSpPr txBox="1"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7" name="Google Shape;37;p11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1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12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3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3"/>
          <p:cNvSpPr txBox="1">
            <a:spLocks noGrp="1"/>
          </p:cNvSpPr>
          <p:nvPr>
            <p:ph type="body" idx="1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4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>
            <a:spLocks noGrp="1"/>
          </p:cNvSpPr>
          <p:nvPr>
            <p:ph type="pic" idx="2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58" name="Google Shape;58;p14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1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1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 rot="5400000">
            <a:off x="1772576" y="3622015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-1227799" y="2186121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Google Shape;174;p20"/>
          <p:cNvSpPr txBox="1"/>
          <p:nvPr/>
        </p:nvSpPr>
        <p:spPr>
          <a:xfrm>
            <a:off x="384538" y="7105988"/>
            <a:ext cx="6088924" cy="19389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</a:rPr>
              <a:t>Supplemental </a:t>
            </a:r>
            <a:r>
              <a:rPr lang="en-US" sz="1200" b="1">
                <a:solidFill>
                  <a:schemeClr val="dk1"/>
                </a:solidFill>
              </a:rPr>
              <a:t>Figure S1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with TaAmy1.B2 (ATY36097.1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; -amylase 1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B2), TaAmy1.2 (ATY36099.1; α-amylase 1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D2), and TaAmy1.3 (ATY36098.1; amylase 1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D1). Amino acid differences  between the three TaAmy1 homeologs are shown in bold in both the consensus sequences and in peptide alignments.  Peptides are shown in alternating colors (black/red) and those with the same amino acid sequences are stacked to show the number of times a peptide sequence was recovered from peptide sequencing analysis. In total 30 unique peptides were recovered for the three TaAmy1 homologs. Percent coverages for TaAmy1.1, TaAmy1.2, and TaAmy1.3 were 45.33%, 43.79%, and 45.9%, respectively. 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75" name="Google Shape;175;p2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80060" y="608729"/>
            <a:ext cx="5798820" cy="641691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Google Shape;180;p21"/>
          <p:cNvSpPr txBox="1"/>
          <p:nvPr/>
        </p:nvSpPr>
        <p:spPr>
          <a:xfrm>
            <a:off x="453390" y="5161570"/>
            <a:ext cx="5833110" cy="13849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</a:rPr>
              <a:t>Supplemental </a:t>
            </a:r>
            <a:r>
              <a:rPr lang="en-US" sz="1200" b="1">
                <a:solidFill>
                  <a:schemeClr val="dk1"/>
                </a:solidFill>
              </a:rPr>
              <a:t>Figure S2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with TaAmy2 (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TY36101.1; Amy2). Peptides are shown in alternating colors (black/red) and those with the same amino acid sequences are stacked to show the number of times a peptide sequence was recovered from peptide sequencing analysis. In total coverage 27 peptides for TaAmy2 were recovered and represent 55% amino acid sequence coverage.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81" name="Google Shape;181;p2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57200" y="460901"/>
            <a:ext cx="5943600" cy="432511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Google Shape;186;p22"/>
          <p:cNvSpPr txBox="1"/>
          <p:nvPr/>
        </p:nvSpPr>
        <p:spPr>
          <a:xfrm>
            <a:off x="396300" y="6079162"/>
            <a:ext cx="6111180" cy="17542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</a:rPr>
              <a:t>Supplemental </a:t>
            </a:r>
            <a:r>
              <a:rPr lang="en-US" sz="1200" b="1">
                <a:solidFill>
                  <a:schemeClr val="dk1"/>
                </a:solidFill>
              </a:rPr>
              <a:t>Figure S3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with TaAmy4.1 (ATY36107.1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; α-amylase 4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D), and TaAmy4.2 (ATY36106.1; α-amylase 4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B). Amino acid differences between the two TaAmy4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s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are shown in bold in both the consensus sequences and in peptide alignments.  Peptides are shown in alternating colors (black/red) and those with the same amino acid sequences are stacked to show the number of times a peptide sequence was recovered from peptide sequencing analysis. In total 22 unique peptides were recovered for the two TaAmy4 homologs. Percent coverages for TaAmy4.1, and TaAmy4.2, were 41.5%, and 39.6%, respectively. 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87" name="Google Shape;187;p2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57200" y="545592"/>
            <a:ext cx="5943600" cy="547725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Google Shape;174;p20">
            <a:extLst>
              <a:ext uri="{FF2B5EF4-FFF2-40B4-BE49-F238E27FC236}">
                <a16:creationId xmlns:a16="http://schemas.microsoft.com/office/drawing/2014/main" id="{FC0717F2-AC88-49D0-8013-225CE043CECB}"/>
              </a:ext>
            </a:extLst>
          </p:cNvPr>
          <p:cNvSpPr txBox="1"/>
          <p:nvPr/>
        </p:nvSpPr>
        <p:spPr>
          <a:xfrm>
            <a:off x="384538" y="7808464"/>
            <a:ext cx="6088924" cy="1200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</a:t>
            </a:r>
            <a:r>
              <a:rPr lang="en-US" sz="1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4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</a:t>
            </a:r>
            <a:r>
              <a:rPr lang="en-US" sz="1200" dirty="0">
                <a:solidFill>
                  <a:schemeClr val="dk1"/>
                </a:solidFill>
              </a:rPr>
              <a:t>from heterologously expressed 6xHIS TaAMY1 peptides with  wheat TaAMY1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Peptides are shown in alternating colors (black/red) and those with the same amino acid sequences are stacked to show the number of times a peptide sequence was recovered from peptide sequencing analysis. In total </a:t>
            </a:r>
            <a:r>
              <a:rPr lang="en-US" sz="1200" dirty="0"/>
              <a:t>14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unique peptides were recovered with 56%  total coverage.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E505656-9373-4CF1-8A4E-151028FD94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9948" y="547499"/>
            <a:ext cx="5438103" cy="72609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56143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13E4889-D946-4ED4-87A2-87BB470DFE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4720" y="528319"/>
            <a:ext cx="5547359" cy="7274561"/>
          </a:xfrm>
          <a:prstGeom prst="rect">
            <a:avLst/>
          </a:prstGeom>
        </p:spPr>
      </p:pic>
      <p:sp>
        <p:nvSpPr>
          <p:cNvPr id="5" name="Google Shape;174;p20">
            <a:extLst>
              <a:ext uri="{FF2B5EF4-FFF2-40B4-BE49-F238E27FC236}">
                <a16:creationId xmlns:a16="http://schemas.microsoft.com/office/drawing/2014/main" id="{905F0CD2-8CE1-4DEB-8C4A-47FFA6D408C5}"/>
              </a:ext>
            </a:extLst>
          </p:cNvPr>
          <p:cNvSpPr txBox="1"/>
          <p:nvPr/>
        </p:nvSpPr>
        <p:spPr>
          <a:xfrm>
            <a:off x="393155" y="7802880"/>
            <a:ext cx="6088924" cy="1200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</a:t>
            </a:r>
            <a:r>
              <a:rPr lang="en-US" sz="1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5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</a:t>
            </a:r>
            <a:r>
              <a:rPr lang="en-US" sz="1200" dirty="0">
                <a:solidFill>
                  <a:schemeClr val="dk1"/>
                </a:solidFill>
              </a:rPr>
              <a:t>from heterologously expressed 6xHIS TaAMY1 peptides with  wheat TaAMY2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Peptides are shown in alternating colors (black/red) and those with the same amino acid sequences are stacked to show the number of times a peptide sequence was recovered from peptide sequencing analysis. In total 22 unique peptides were recovered with </a:t>
            </a:r>
            <a:r>
              <a:rPr lang="en-US" sz="1200" dirty="0"/>
              <a:t>47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% total coverage.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63656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Google Shape;174;p20">
            <a:extLst>
              <a:ext uri="{FF2B5EF4-FFF2-40B4-BE49-F238E27FC236}">
                <a16:creationId xmlns:a16="http://schemas.microsoft.com/office/drawing/2014/main" id="{CC4FCD4A-746E-4E8B-B1AF-65C1AF316817}"/>
              </a:ext>
            </a:extLst>
          </p:cNvPr>
          <p:cNvSpPr txBox="1"/>
          <p:nvPr/>
        </p:nvSpPr>
        <p:spPr>
          <a:xfrm>
            <a:off x="384538" y="7070725"/>
            <a:ext cx="6088924" cy="1200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</a:t>
            </a:r>
            <a:r>
              <a:rPr lang="en-US" sz="1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6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</a:t>
            </a:r>
            <a:r>
              <a:rPr lang="en-US" sz="1200" dirty="0">
                <a:solidFill>
                  <a:schemeClr val="dk1"/>
                </a:solidFill>
              </a:rPr>
              <a:t>from heterologously expressed 6xHIS TaAMY4 peptides with  wheat TaAMY4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Peptides are shown in alternating colors (black/red) and those with the same amino acid sequences are stacked to show the number of times a peptide sequence was recovered from peptide sequencing analysis. In total </a:t>
            </a:r>
            <a:r>
              <a:rPr lang="en-US" sz="1200" dirty="0"/>
              <a:t>14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unique peptides were recovered with 39% total coverage. 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7055F0D-4FA2-4867-9866-B4EFC4CAE3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2127" y="872987"/>
            <a:ext cx="5499069" cy="6102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7260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8</TotalTime>
  <Words>534</Words>
  <Application>Microsoft Office PowerPoint</Application>
  <PresentationFormat>On-screen Show (4:3)</PresentationFormat>
  <Paragraphs>7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ber, Camille</dc:creator>
  <cp:lastModifiedBy>MDPI</cp:lastModifiedBy>
  <cp:revision>21</cp:revision>
  <dcterms:created xsi:type="dcterms:W3CDTF">2021-03-09T22:22:12Z</dcterms:created>
  <dcterms:modified xsi:type="dcterms:W3CDTF">2023-11-08T02:08:26Z</dcterms:modified>
</cp:coreProperties>
</file>